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3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11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CE9C14-49AA-410F-8506-F9DDB2B176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46D3E73-6BC1-40B5-BC8D-77A8D8AF84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974C6E7-75A6-4825-AC04-F59127691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CB8F383-BEC2-4DF9-9DB4-6BE01D5B3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447B197-B230-4E1E-8535-265DCBABE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494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B4B9B45-F6E7-485C-B327-9CEDEF79F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B51DC2F-B54C-42D0-89A5-A2FE77774A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8D4B5B-1029-4FA6-9288-9EE31B7CFA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E2B129D-26B2-4CF5-ABEC-AA542726B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172E2C0-A96B-4230-ADBF-6441FE164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38397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DC30D51-5275-4250-BB5E-2666FAAEB7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0D331C3-ADA3-4179-B5E9-1E95C4B126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E26D8E-A87D-4C2A-903F-B44B2E373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D45C317-59FE-4627-B56A-F35A1D02F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C078D54-D48C-46BC-896A-6271E4E32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17133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C9DDC6-D5B8-42F2-A25F-1D17BEFDC1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59230E1-2834-4042-9CEA-97EF9F6077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98897B4-9002-44EC-973D-8641EFC49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B2EDCD-0A07-4DEE-9151-E301A630C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7CE34E1-EEFE-429A-8E21-CC803C094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66228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08DFAF-10D2-43A8-BCC0-58D71FC2A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07EE8B7-B2B8-4638-82D1-1A2851651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9652EEF-52E9-4952-814F-7181BD572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A50DE38-CCF4-48AC-A394-79D8CED99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8607F61-E17F-494C-A43F-EEEB27AE2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86468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14A5CEB-AA82-4B62-A7C2-BB9B3EC67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64161F6-7D1D-4C88-862E-1B8D6159C4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5DBC74B-6371-45B2-B6B6-3B26BADBC1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B91DB96-181A-4F9E-A535-E79BAFF2D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EB5843F-0089-4717-B1EC-34F94D165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1BBEBA2-9503-4973-82B0-86D07E39A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97741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D6B3FC-C36A-40A3-B97A-1C195EDEE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047E717-C0B3-49B5-AFC8-F904F6C94A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8B1F5BF-D15A-498E-9DD5-102588E344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0612CC83-20D8-4595-869F-E38AABB491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DF6E2A4-95CC-494F-9987-033B4B7B7B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6BA0490-9895-4F5F-A454-DDFDFFBCD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090DC84-530F-493E-BA89-9C6C26992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B8F9B87-AF9D-4099-86BD-4A5DFBF41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8203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619D4D-A816-4BC3-BC81-B15E64114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D9A917E-B923-4E6B-8CBF-C330DE628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753A6EE-DA3D-4ACF-9DF9-E02D50974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174413C-D32B-49DB-9432-502121EAE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43270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BB83C9B-EE27-418E-864D-4DA35F174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1F17477-46AE-4074-90CF-7567FFDAC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8EA0D76-1EB4-414B-8FF1-6C7107E84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5733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AF2BCF-AACF-4061-873D-CFE92EA6E6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AD4C382-A902-449E-94DE-A9541988E6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04C0184-AF7E-4683-9E63-BCD76081FE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3AC7C4D-1D65-425C-BC9E-E48D7A7D9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E9B7B12-B0C4-4C62-929E-A0DDC5BD0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B6BE7BD-A30E-44D9-A9F5-C01C4C7E5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5938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2AE33CA-170B-4609-9BC4-C6F426C3A8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98C4919-C8A1-4453-BEE5-AA76ECC7B8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37BAF98-6661-43B3-97AF-4E6FCF059D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DCBDE63-A674-44CB-87F0-D25100A8E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33449D7-91FE-44C4-B952-D0F4DFC9F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570B970-7D72-49F3-9F47-EE690CDFA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03146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E3090C8-D390-4A68-B935-FC7E1C29B3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E133B6C-BBEC-49C9-8EB4-22C144B5A7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D1FE085-4A5E-4DB0-AEB4-B0F64DB1DB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2609A-2E50-4B42-BAF1-55AEB4B16BC3}" type="datetimeFigureOut">
              <a:rPr lang="es-CO" smtClean="0"/>
              <a:t>29/01/21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4C11618-10C3-4DDF-A743-6A315C4C59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020B722-7756-49EE-90C9-24F0B25256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51BE39-9B76-4656-91BC-50C758ED128B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20742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Imagen 61" descr="Imagen que contiene exterior, foto, pasto, frente&#10;&#10;Descripción generada automáticamente">
            <a:extLst>
              <a:ext uri="{FF2B5EF4-FFF2-40B4-BE49-F238E27FC236}">
                <a16:creationId xmlns:a16="http://schemas.microsoft.com/office/drawing/2014/main" id="{B38BEF6D-3E92-420F-A2E1-DE53F82EED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179338"/>
            <a:ext cx="2561914" cy="235926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1" name="Imagen 60" descr="Imagen que contiene exterior, roca, rocoso, foto&#10;&#10;Descripción generada automáticamente">
            <a:extLst>
              <a:ext uri="{FF2B5EF4-FFF2-40B4-BE49-F238E27FC236}">
                <a16:creationId xmlns:a16="http://schemas.microsoft.com/office/drawing/2014/main" id="{8EF3A06E-29C4-44EF-B078-2AF7AFEB4E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3823" y="1179338"/>
            <a:ext cx="2561914" cy="235926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4" name="Rectángulo 33">
            <a:extLst>
              <a:ext uri="{FF2B5EF4-FFF2-40B4-BE49-F238E27FC236}">
                <a16:creationId xmlns:a16="http://schemas.microsoft.com/office/drawing/2014/main" id="{563B29FA-3D60-436A-8720-C42D0247C908}"/>
              </a:ext>
            </a:extLst>
          </p:cNvPr>
          <p:cNvSpPr/>
          <p:nvPr/>
        </p:nvSpPr>
        <p:spPr>
          <a:xfrm>
            <a:off x="3352800" y="3369827"/>
            <a:ext cx="2561914" cy="17222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299B6C93-C73F-4E00-A905-FEC60E689569}"/>
              </a:ext>
            </a:extLst>
          </p:cNvPr>
          <p:cNvCxnSpPr>
            <a:cxnSpLocks/>
          </p:cNvCxnSpPr>
          <p:nvPr/>
        </p:nvCxnSpPr>
        <p:spPr>
          <a:xfrm>
            <a:off x="4578066" y="3401723"/>
            <a:ext cx="1288804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5" name="CuadroTexto 34">
            <a:extLst>
              <a:ext uri="{FF2B5EF4-FFF2-40B4-BE49-F238E27FC236}">
                <a16:creationId xmlns:a16="http://schemas.microsoft.com/office/drawing/2014/main" id="{10144C6D-5A2C-4397-9F45-7835A33AB7AE}"/>
              </a:ext>
            </a:extLst>
          </p:cNvPr>
          <p:cNvSpPr txBox="1"/>
          <p:nvPr/>
        </p:nvSpPr>
        <p:spPr>
          <a:xfrm>
            <a:off x="3391411" y="3330625"/>
            <a:ext cx="759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0 ºC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D30E1754-46CB-45BF-A7CB-3E61385BE124}"/>
              </a:ext>
            </a:extLst>
          </p:cNvPr>
          <p:cNvSpPr txBox="1"/>
          <p:nvPr/>
        </p:nvSpPr>
        <p:spPr>
          <a:xfrm>
            <a:off x="4809194" y="3354021"/>
            <a:ext cx="7974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l-GR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s-E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05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ángulo 36">
            <a:extLst>
              <a:ext uri="{FF2B5EF4-FFF2-40B4-BE49-F238E27FC236}">
                <a16:creationId xmlns:a16="http://schemas.microsoft.com/office/drawing/2014/main" id="{D2E62C59-71D6-4796-9CCA-363CD4EC343A}"/>
              </a:ext>
            </a:extLst>
          </p:cNvPr>
          <p:cNvSpPr/>
          <p:nvPr/>
        </p:nvSpPr>
        <p:spPr>
          <a:xfrm>
            <a:off x="6096000" y="3361200"/>
            <a:ext cx="2561914" cy="17222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Conector recto 37">
            <a:extLst>
              <a:ext uri="{FF2B5EF4-FFF2-40B4-BE49-F238E27FC236}">
                <a16:creationId xmlns:a16="http://schemas.microsoft.com/office/drawing/2014/main" id="{1CE7D5A5-3359-4180-8158-148DD5669A52}"/>
              </a:ext>
            </a:extLst>
          </p:cNvPr>
          <p:cNvCxnSpPr>
            <a:cxnSpLocks/>
          </p:cNvCxnSpPr>
          <p:nvPr/>
        </p:nvCxnSpPr>
        <p:spPr>
          <a:xfrm>
            <a:off x="7321266" y="3393096"/>
            <a:ext cx="1288804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9" name="CuadroTexto 38">
            <a:extLst>
              <a:ext uri="{FF2B5EF4-FFF2-40B4-BE49-F238E27FC236}">
                <a16:creationId xmlns:a16="http://schemas.microsoft.com/office/drawing/2014/main" id="{C37C6C6D-76D0-4DD1-9BA6-7B96A14FEE3C}"/>
              </a:ext>
            </a:extLst>
          </p:cNvPr>
          <p:cNvSpPr txBox="1"/>
          <p:nvPr/>
        </p:nvSpPr>
        <p:spPr>
          <a:xfrm>
            <a:off x="6134611" y="3321998"/>
            <a:ext cx="797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0 ºC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80AFC077-75BC-4B82-933A-8147C8949F4C}"/>
              </a:ext>
            </a:extLst>
          </p:cNvPr>
          <p:cNvSpPr txBox="1"/>
          <p:nvPr/>
        </p:nvSpPr>
        <p:spPr>
          <a:xfrm>
            <a:off x="7552394" y="3345394"/>
            <a:ext cx="7974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l-GR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s-E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05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9" name="Imagen 68" descr="Imagen que contiene foto, frente, grande, flor&#10;&#10;Descripción generada automáticamente">
            <a:extLst>
              <a:ext uri="{FF2B5EF4-FFF2-40B4-BE49-F238E27FC236}">
                <a16:creationId xmlns:a16="http://schemas.microsoft.com/office/drawing/2014/main" id="{557E1021-6193-49D1-AEF6-0D8C114D15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0402" y="3677607"/>
            <a:ext cx="2561915" cy="235926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1" name="Imagen 70">
            <a:extLst>
              <a:ext uri="{FF2B5EF4-FFF2-40B4-BE49-F238E27FC236}">
                <a16:creationId xmlns:a16="http://schemas.microsoft.com/office/drawing/2014/main" id="{FE5F67C8-C1C5-4E3F-AE21-E1B3FC8026F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3758" y="3677605"/>
            <a:ext cx="2561914" cy="235926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2" name="Rectángulo 71">
            <a:extLst>
              <a:ext uri="{FF2B5EF4-FFF2-40B4-BE49-F238E27FC236}">
                <a16:creationId xmlns:a16="http://schemas.microsoft.com/office/drawing/2014/main" id="{E3C53014-7F6B-439B-A352-7CDA7043022B}"/>
              </a:ext>
            </a:extLst>
          </p:cNvPr>
          <p:cNvSpPr/>
          <p:nvPr/>
        </p:nvSpPr>
        <p:spPr>
          <a:xfrm>
            <a:off x="3353758" y="5864642"/>
            <a:ext cx="2561914" cy="17222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Conector recto 72">
            <a:extLst>
              <a:ext uri="{FF2B5EF4-FFF2-40B4-BE49-F238E27FC236}">
                <a16:creationId xmlns:a16="http://schemas.microsoft.com/office/drawing/2014/main" id="{F62C9460-B721-485F-8705-09318A56CDA1}"/>
              </a:ext>
            </a:extLst>
          </p:cNvPr>
          <p:cNvCxnSpPr>
            <a:cxnSpLocks/>
          </p:cNvCxnSpPr>
          <p:nvPr/>
        </p:nvCxnSpPr>
        <p:spPr>
          <a:xfrm>
            <a:off x="4579024" y="5896538"/>
            <a:ext cx="1288804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74" name="CuadroTexto 73">
            <a:extLst>
              <a:ext uri="{FF2B5EF4-FFF2-40B4-BE49-F238E27FC236}">
                <a16:creationId xmlns:a16="http://schemas.microsoft.com/office/drawing/2014/main" id="{2A106EFC-1E0E-49B9-9C4C-B5002D4397A9}"/>
              </a:ext>
            </a:extLst>
          </p:cNvPr>
          <p:cNvSpPr txBox="1"/>
          <p:nvPr/>
        </p:nvSpPr>
        <p:spPr>
          <a:xfrm>
            <a:off x="3392369" y="5825440"/>
            <a:ext cx="759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0 ºC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EDD5CEF8-9015-4230-A326-613FD8E9DCFA}"/>
              </a:ext>
            </a:extLst>
          </p:cNvPr>
          <p:cNvSpPr txBox="1"/>
          <p:nvPr/>
        </p:nvSpPr>
        <p:spPr>
          <a:xfrm>
            <a:off x="4810152" y="5848836"/>
            <a:ext cx="7974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l-GR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s-E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05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ángulo 75">
            <a:extLst>
              <a:ext uri="{FF2B5EF4-FFF2-40B4-BE49-F238E27FC236}">
                <a16:creationId xmlns:a16="http://schemas.microsoft.com/office/drawing/2014/main" id="{27C8C02F-BBD2-4FDE-BBDD-A5DA1CA46FD3}"/>
              </a:ext>
            </a:extLst>
          </p:cNvPr>
          <p:cNvSpPr/>
          <p:nvPr/>
        </p:nvSpPr>
        <p:spPr>
          <a:xfrm>
            <a:off x="6096958" y="5856015"/>
            <a:ext cx="2561914" cy="17222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7" name="Conector recto 76">
            <a:extLst>
              <a:ext uri="{FF2B5EF4-FFF2-40B4-BE49-F238E27FC236}">
                <a16:creationId xmlns:a16="http://schemas.microsoft.com/office/drawing/2014/main" id="{D3BB9FAB-9628-4FC0-88A3-C65A10FF27E1}"/>
              </a:ext>
            </a:extLst>
          </p:cNvPr>
          <p:cNvCxnSpPr>
            <a:cxnSpLocks/>
          </p:cNvCxnSpPr>
          <p:nvPr/>
        </p:nvCxnSpPr>
        <p:spPr>
          <a:xfrm>
            <a:off x="7322224" y="5887911"/>
            <a:ext cx="1288804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78" name="CuadroTexto 77">
            <a:extLst>
              <a:ext uri="{FF2B5EF4-FFF2-40B4-BE49-F238E27FC236}">
                <a16:creationId xmlns:a16="http://schemas.microsoft.com/office/drawing/2014/main" id="{909DB022-1FC6-4A1E-90B0-446C60DA00A2}"/>
              </a:ext>
            </a:extLst>
          </p:cNvPr>
          <p:cNvSpPr txBox="1"/>
          <p:nvPr/>
        </p:nvSpPr>
        <p:spPr>
          <a:xfrm>
            <a:off x="6135569" y="5816813"/>
            <a:ext cx="797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50 ºC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A17EC8D0-8884-4751-9086-D259F9440EDE}"/>
              </a:ext>
            </a:extLst>
          </p:cNvPr>
          <p:cNvSpPr txBox="1"/>
          <p:nvPr/>
        </p:nvSpPr>
        <p:spPr>
          <a:xfrm>
            <a:off x="7553352" y="5840209"/>
            <a:ext cx="7974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l-GR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s-ES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05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Rectángulo 87">
            <a:extLst>
              <a:ext uri="{FF2B5EF4-FFF2-40B4-BE49-F238E27FC236}">
                <a16:creationId xmlns:a16="http://schemas.microsoft.com/office/drawing/2014/main" id="{D03EEFD5-6835-4FA4-853E-BC4D06A2D4FB}"/>
              </a:ext>
            </a:extLst>
          </p:cNvPr>
          <p:cNvSpPr/>
          <p:nvPr/>
        </p:nvSpPr>
        <p:spPr>
          <a:xfrm>
            <a:off x="3352800" y="1175887"/>
            <a:ext cx="564924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89" name="Rectángulo 88">
            <a:extLst>
              <a:ext uri="{FF2B5EF4-FFF2-40B4-BE49-F238E27FC236}">
                <a16:creationId xmlns:a16="http://schemas.microsoft.com/office/drawing/2014/main" id="{568B02FD-13E0-4749-95AE-97086A64A1BF}"/>
              </a:ext>
            </a:extLst>
          </p:cNvPr>
          <p:cNvSpPr/>
          <p:nvPr/>
        </p:nvSpPr>
        <p:spPr>
          <a:xfrm>
            <a:off x="3352800" y="3677605"/>
            <a:ext cx="564924" cy="3077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3C5F957E-1FE7-47FD-9532-6AD46F05DEC2}"/>
              </a:ext>
            </a:extLst>
          </p:cNvPr>
          <p:cNvSpPr txBox="1"/>
          <p:nvPr/>
        </p:nvSpPr>
        <p:spPr>
          <a:xfrm>
            <a:off x="619125" y="95250"/>
            <a:ext cx="11277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dirty="0"/>
              <a:t>Figure X. SEM images of samples treated at 900 and 950 ºC a) after 3 days and b) after 7 days of soaking in SBF. </a:t>
            </a:r>
          </a:p>
        </p:txBody>
      </p:sp>
    </p:spTree>
    <p:extLst>
      <p:ext uri="{BB962C8B-B14F-4D97-AF65-F5344CB8AC3E}">
        <p14:creationId xmlns:p14="http://schemas.microsoft.com/office/powerpoint/2010/main" val="39299995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3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han Salazar</dc:creator>
  <cp:lastModifiedBy>Astrid Lorena Giraldo Betancur</cp:lastModifiedBy>
  <cp:revision>3</cp:revision>
  <dcterms:created xsi:type="dcterms:W3CDTF">2021-01-28T23:27:34Z</dcterms:created>
  <dcterms:modified xsi:type="dcterms:W3CDTF">2021-01-29T21:22:54Z</dcterms:modified>
</cp:coreProperties>
</file>